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C96EA-9F83-44B6-BB44-AC1D3A17A6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2061C-7763-4787-9740-8D526F8DE8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FB3F638E-085C-4661-8A0F-C036DB08BB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DD9209E-F016-477B-AFC0-31B2CD1327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B07CFEAE-E322-4422-BCA6-C8EB0F2273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43090E32-C9AE-4AD5-BDEF-EF1B15C939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29BC3D7-562E-4D0B-BE15-FE97848F53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1E66F7F-5492-42E9-B908-C47F702531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EA2040F-A7AC-43F0-B403-99266F41DC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EAC4503-86B2-4DA5-ACA5-FD21F20F6F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B2114EB-3E57-485F-95A3-CA0C5DB88F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2AECED7B-D235-4523-96A6-2F5C4B3680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EA2FB-3CEB-4F22-8D44-05F9913287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DCCB9AA-D6D9-451D-A724-5C12D29515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03CD1B7-D806-452C-A82B-B88E2C91E6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C3EFFD3C-6246-411A-95A3-733773A061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1E4A26D3-AE34-468B-8FE4-EF466179A4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0E8A8D3-2389-41B2-A062-8924DD7886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6BC15F6D-BEE3-4DC0-A72C-CC33DD4DF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8CF6C1E-1551-4D29-A8A8-0D096F950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E9A1B93-1372-4BEE-A5FB-4F8DF3530B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F6DAAD6-C576-4CA2-A838-02ADA74BD6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0BD09AA-77E8-447B-985D-766AECE68A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89DDC-4A40-4EB0-AC5E-45FDC27A68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C11BDFB-3CB8-40D7-9CC4-AA9E1050C1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BCC8293D-7398-4851-871B-6D783D85CC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0B09445-D632-4CD4-A564-F9257A3AAB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03EE4CD-16A0-48FF-B6AB-C24C64D621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690FAE0-55A3-4671-879A-99DBBE620C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B8F1A9B-D528-46BC-8528-C3F8BB0F19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EA38B5E-369A-43B1-BD10-145857E0B6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85E780D5-E93C-44C8-8C68-75564DA8E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C8BCE0F-60B4-42CA-8BA9-DEAB40D566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10687FDD-5B23-49C6-9A36-AF868004A7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085EF78-6C68-497F-A3F7-D099F3F084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75702946-4A4A-457B-B5A6-1545FDBC7E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E87F955-080E-4B5A-A06F-02D92CC100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F60666E-F186-48DF-97DA-136D447E3F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1AF9388-20C7-4A2F-A3AC-471040777C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E6C799A6-BD26-4886-BBD6-164C96F014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E83C8FF1-D242-4595-B2F1-8909F0CBCF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74B1A54-1A9C-4D83-BE08-39CD558C7E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C8DCE40-2A8F-4024-B9EF-7567DCA298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2091987-1152-4689-A082-A9C74C6C2F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B047B1E9-9A21-4610-9788-01B49FB341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DFDEDB5-8862-4EB7-9DD8-6496CF88E7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F74B11F-7C8F-4FA3-BC5C-E161EB3C7B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6F0B102D-2A4D-4DF8-85E1-3A36EB79B6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4F8102F-6563-4714-B3A2-569AF59371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8AAE1E5-DD3A-4C54-BBBC-47BDC541FF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F0E71109-8897-4FCB-8846-6EFA5CF9BD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E40B073-9B29-4035-A6FA-9C00131451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3BED8D7-70A3-4B53-B5DA-524F3E7793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1F89883-6387-437F-B7EE-9F9F0EF315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6E54949-F0F0-4E32-A90D-6556EA67CE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A2BDF26-B5B3-4A5A-91ED-2732A305E0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4D1CE-72D2-4E40-B270-80D64935AE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84E5BC5-7AFE-4FA5-986A-418B6BAD34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FB7B56D-420F-417C-86F6-F479AF1F9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B63F94D-8A5E-43C0-AE72-B72B4E8F73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FEB809A-3289-41C9-B4D8-700DFE1A13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981677E-967A-46E6-BCB0-20DFEAA5B8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594B8A61-53AD-44F8-A8A4-173A29DA01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94802E1-7511-430E-BE0C-0394286325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A74CC005-BF64-4905-928D-5D4B897869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6392197-7A3C-47F0-9A69-A49CF9FB9F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4B553CD5-D6B3-45BD-B3D8-01B71AED0C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9BA2B-4D92-4F6C-A0FB-980488DD48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FFF979A-5161-4D2B-BCF0-12046B10C3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A4BA2CA0-9006-4669-8428-8DABA1BA0D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AE3D873-9249-43D0-92FE-C8841328E3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4F502E76-7E23-41F7-A6BB-AE3B0F90B6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84026425-7FFA-42F4-BBF5-B02A03BA66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117F9AF6-466C-4490-B06A-7D77AC3738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A594F3E-069D-4A28-8956-75911FB4B2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886BEEED-9804-41E3-ABFC-2E8EF6DDF3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A8BEE172-C467-4ED4-AEE1-8809F699B6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7E8311FA-7F97-4BF6-9638-9E38029A11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BED48-F3F4-4F11-846C-D8158796D9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72BBBCEF-9967-43F7-B2C7-6A59F7A441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F47508D9-AA02-4C41-9179-FCA5055F67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B73F4E84-1055-4A0B-A79B-905528EAC7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94D48DC-4369-445A-9097-B3F3A934A8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096DDEEA-AE7E-4443-A4E6-370427A5E4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7BC11B59-410C-48E4-AEE0-080D0265EF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A2C1D4D-CC99-4E82-A2F3-245DD53CBC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27AE873-364C-4444-8140-43D89445CB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5BEED0AC-6527-460C-A1F3-122D58CDD4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97EAE917-D9AA-41CB-8A6D-AC5E1CC81C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4C4AA-AD50-40A5-81FE-7EC9D966E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EE0841A4-50E8-4B1F-BF9F-193270594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E77FF4A0-865C-4804-9716-7134977DF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AA50AD2D-02EC-4C78-B3BA-AF3ADA13E2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6E31558A-CA06-4DEB-ABB2-0EC546AFF8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F2FFAB29-DFB0-499A-87E7-A6805F95A9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D029F78F-BFAD-43D0-902C-900071F8B6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45C766AB-C6DB-4E59-82EE-C7A1DEF914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9FAE8831-1AA2-486A-B8D4-91B04A0FBA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245EEFAA-5EAA-4B7A-B31E-E10B606589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7E73B88B-8857-4944-B21B-E215A96266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B079A-24D0-4A72-AC20-94B5AB6185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175F4F16-3497-4892-A75B-C3151F0EDB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0DD6A46-BC1F-4D5F-B4D4-7D02FE34AF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31560DA-9541-41E3-A926-8612ACEEED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BE8F6C9-A96B-4473-88BF-D62390AEA2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8A5B937-DC70-4B5D-A495-C4ADB88301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5C5A6E42-9041-4984-B9EE-7504E3328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D6AAD430-2CF0-4BF3-817A-D3548376FF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C24E955-4138-4949-BE94-82D3E0CF31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B53F137-B958-4BC8-A3E2-BE6E14D439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302AEB8-E1FC-433A-8C43-B10A86CF92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BB79B-1F42-46AF-BA00-2DC4C5A935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B6F3941-1AE7-4A49-B779-4F1EFF2723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BEDE5D5-0D38-48B3-8C78-0A79A4324E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FEAFA08-A83E-4B7F-BEB4-0B615D5337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C9016988-FF43-4648-80F8-809239322F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7D610B23-B08E-4FF1-9875-9581260F36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F164521-2CBF-4EEB-AED9-544D7DAD29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5DF6AAC1-C40C-462E-9C70-7752F724D7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EDE77F4-2514-4C4E-ADAB-5EB67587C9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9B2863A3-1970-4FE1-8FD0-0786D2CE6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12413D1F-B584-4E4F-A2DF-BA7AA1A34C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9DC55-B443-461A-9ECC-48308BF75E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7EEF01E4-16F0-468D-B126-B0BDA1588E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47A7B3C-34D4-4521-B213-38384D1BDC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1EDC65A2-0B33-4CAC-8640-E2F2D472B1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0F4F5C5-B925-4F85-902E-2D3AB17ABB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6201A48-5DC4-4D56-ACE1-84C7EF11CC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305A8CAE-E7DD-49E9-98ED-9C09B4BB7D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4B447112-349A-421C-8475-64CB375818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4960466-35DB-4B68-BE49-DF327301F9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B2AA023-CC06-4854-B825-02032124DB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4C3461F1-FD1C-42AC-B6B3-EB52582784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2877E-8627-4E94-A8C3-FE9C0DAFCD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45EE983-8B00-4C51-94DD-A07E6A1141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DAE2BB3-5D80-4EFB-A755-36E10B99A7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A98A4970-C974-4DB6-A821-E89708FFD5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3B4AF101-B4DA-427C-8D78-093B27957E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764F220-B027-4591-B9CD-4EB8D1D355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DBD0DA54-AC4F-4831-B8CE-776AB6943C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D3BFF3A-4D23-4034-A52E-4004FE2761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01B7EBB-8411-41E1-A0BA-465FC80703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E7A5709E-017B-41DE-BAD6-0CE37C99BA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7E83BB6-4D95-474A-92C1-86A29C82D1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72385D-D9FC-4C72-AC31-20A88360FEA7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1"/>
          <p:cNvSpPr>
            <a:spLocks noGrp="1"/>
          </p:cNvSpPr>
          <p:nvPr>
            <p:ph type="sldNum" idx="28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E73D9F-947E-4A4D-B38B-60B79E9AE25C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2" name="PlaceHolder 4"/>
          <p:cNvSpPr>
            <a:spLocks noGrp="1"/>
          </p:cNvSpPr>
          <p:nvPr>
            <p:ph type="dt" idx="29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3" name="PlaceHolder 5"/>
          <p:cNvSpPr>
            <a:spLocks noGrp="1"/>
          </p:cNvSpPr>
          <p:nvPr>
            <p:ph type="ftr" idx="30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1"/>
          <p:cNvSpPr>
            <a:spLocks noGrp="1"/>
          </p:cNvSpPr>
          <p:nvPr>
            <p:ph type="sldNum" idx="31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541B19-E7A9-4D8A-B196-FE0CC5E2F0F7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3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4" name="PlaceHolder 4"/>
          <p:cNvSpPr>
            <a:spLocks noGrp="1"/>
          </p:cNvSpPr>
          <p:nvPr>
            <p:ph type="dt" idx="32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5" name="PlaceHolder 5"/>
          <p:cNvSpPr>
            <a:spLocks noGrp="1"/>
          </p:cNvSpPr>
          <p:nvPr>
            <p:ph type="ftr" idx="33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PlaceHolder 1"/>
          <p:cNvSpPr>
            <a:spLocks noGrp="1"/>
          </p:cNvSpPr>
          <p:nvPr>
            <p:ph type="sldNum" idx="34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3F5824-F2BA-41D9-A39D-A92AAF496630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6" name="PlaceHolder 4"/>
          <p:cNvSpPr>
            <a:spLocks noGrp="1"/>
          </p:cNvSpPr>
          <p:nvPr>
            <p:ph type="dt" idx="35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PlaceHolder 5"/>
          <p:cNvSpPr>
            <a:spLocks noGrp="1"/>
          </p:cNvSpPr>
          <p:nvPr>
            <p:ph type="ftr" idx="36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Title Placeholder 1"/>
          <p:cNvSpPr/>
          <p:nvPr/>
        </p:nvSpPr>
        <p:spPr>
          <a:xfrm>
            <a:off x="457200" y="351000"/>
            <a:ext cx="8229600" cy="102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000" spc="-1" strike="noStrike">
                <a:solidFill>
                  <a:srgbClr val="000000"/>
                </a:solidFill>
                <a:latin typeface="Times New Roman"/>
                <a:ea typeface="Arial"/>
              </a:rPr>
              <a:t>SCM6 White Label Figure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Footer Placeholder 4"/>
          <p:cNvSpPr/>
          <p:nvPr/>
        </p:nvSpPr>
        <p:spPr>
          <a:xfrm>
            <a:off x="3124080" y="6248520"/>
            <a:ext cx="38862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  <a:ea typeface="Arial"/>
              </a:rPr>
              <a:t>Copyright © The Publisher. All rights re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1"/>
          <p:cNvSpPr>
            <a:spLocks noGrp="1"/>
          </p:cNvSpPr>
          <p:nvPr>
            <p:ph type="dt" idx="37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Num" idx="4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BAD60F-3114-4343-B0D0-E603E14F661F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5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6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1"/>
          <p:cNvSpPr>
            <a:spLocks noGrp="1"/>
          </p:cNvSpPr>
          <p:nvPr>
            <p:ph type="sldNum" idx="7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56A036-F523-4BD7-8451-28056BD8AF02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 type="dt" idx="8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 type="ftr" idx="9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sldNum" idx="10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1DFB40-3EDE-4EC4-9D16-CD59E43CEFAC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 type="dt" idx="11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PlaceHolder 5"/>
          <p:cNvSpPr>
            <a:spLocks noGrp="1"/>
          </p:cNvSpPr>
          <p:nvPr>
            <p:ph type="ftr" idx="12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sldNum" idx="13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158167-7500-444D-8CAE-E412624A2C99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" name="PlaceHolder 4"/>
          <p:cNvSpPr>
            <a:spLocks noGrp="1"/>
          </p:cNvSpPr>
          <p:nvPr>
            <p:ph type="dt" idx="14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PlaceHolder 5"/>
          <p:cNvSpPr>
            <a:spLocks noGrp="1"/>
          </p:cNvSpPr>
          <p:nvPr>
            <p:ph type="ftr" idx="15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1"/>
          <p:cNvSpPr>
            <a:spLocks noGrp="1"/>
          </p:cNvSpPr>
          <p:nvPr>
            <p:ph type="sldNum" idx="16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8C6219-8ED9-42CC-AE89-EC7835E49AAC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 type="dt" idx="17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 type="ftr" idx="18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1"/>
          <p:cNvSpPr>
            <a:spLocks noGrp="1"/>
          </p:cNvSpPr>
          <p:nvPr>
            <p:ph type="sldNum" idx="19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7EE1A3-557E-4A62-9EC9-63F3691632F6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 type="dt" idx="20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 type="ftr" idx="21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1"/>
          <p:cNvSpPr>
            <a:spLocks noGrp="1"/>
          </p:cNvSpPr>
          <p:nvPr>
            <p:ph type="sldNum" idx="22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213780-8046-480C-B9C3-D37DB419DB50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7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8" name="PlaceHolder 4"/>
          <p:cNvSpPr>
            <a:spLocks noGrp="1"/>
          </p:cNvSpPr>
          <p:nvPr>
            <p:ph type="dt" idx="23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PlaceHolder 5"/>
          <p:cNvSpPr>
            <a:spLocks noGrp="1"/>
          </p:cNvSpPr>
          <p:nvPr>
            <p:ph type="ftr" idx="24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PlaceHolder 1"/>
          <p:cNvSpPr>
            <a:spLocks noGrp="1"/>
          </p:cNvSpPr>
          <p:nvPr>
            <p:ph type="sldNum" idx="25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12C696-7FCE-4392-96C0-714FC3CC07C7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 type="dt" idx="26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 type="ftr" idx="27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6" name="Rectangle 10"/>
          <p:cNvSpPr/>
          <p:nvPr/>
        </p:nvSpPr>
        <p:spPr>
          <a:xfrm>
            <a:off x="0" y="687240"/>
            <a:ext cx="9144000" cy="914400"/>
          </a:xfrm>
          <a:prstGeom prst="rect">
            <a:avLst/>
          </a:prstGeom>
          <a:solidFill>
            <a:srgbClr val="eeeee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Date Placeholder 3"/>
          <p:cNvSpPr/>
          <p:nvPr/>
        </p:nvSpPr>
        <p:spPr>
          <a:xfrm>
            <a:off x="0" y="6222960"/>
            <a:ext cx="254016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63360" bIns="6336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baseline="256000">
                <a:solidFill>
                  <a:srgbClr val="999999"/>
                </a:solidFill>
                <a:latin typeface="Arial"/>
              </a:rPr>
              <a:t>Date of download:  1/8/20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Footer Placeholder 4"/>
          <p:cNvSpPr/>
          <p:nvPr/>
        </p:nvSpPr>
        <p:spPr>
          <a:xfrm>
            <a:off x="2971800" y="6222960"/>
            <a:ext cx="32004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baseline="256000">
                <a:solidFill>
                  <a:srgbClr val="999999"/>
                </a:solidFill>
                <a:latin typeface="Arial"/>
              </a:rPr>
              <a:t>Copyright 2023 American Medical Association. All Rights Reserve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Text Placeholder 2"/>
          <p:cNvSpPr/>
          <p:nvPr/>
        </p:nvSpPr>
        <p:spPr>
          <a:xfrm>
            <a:off x="0" y="692280"/>
            <a:ext cx="9144000" cy="50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6336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From: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Reporting of Factorial Randomized Trials: Extension of the CONSORT 2010 Statemen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Straight Connector 8"/>
          <p:cNvSpPr/>
          <p:nvPr/>
        </p:nvSpPr>
        <p:spPr>
          <a:xfrm flipV="1">
            <a:off x="0" y="6215040"/>
            <a:ext cx="9144000" cy="7920"/>
          </a:xfrm>
          <a:prstGeom prst="line">
            <a:avLst/>
          </a:prstGeom>
          <a:ln w="12600">
            <a:solidFill>
              <a:srgbClr val="99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Text Placeholder 2"/>
          <p:cNvSpPr/>
          <p:nvPr/>
        </p:nvSpPr>
        <p:spPr>
          <a:xfrm>
            <a:off x="0" y="1282680"/>
            <a:ext cx="914400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0" bIns="63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JAMA. 2023;330(21):2106-2114. doi:10.1001/jama.2023.197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Text Placeholder 2"/>
          <p:cNvSpPr/>
          <p:nvPr/>
        </p:nvSpPr>
        <p:spPr>
          <a:xfrm>
            <a:off x="0" y="5575320"/>
            <a:ext cx="91440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0" tIns="0" bIns="63360" anchor="t">
            <a:no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ample of a 2 × 2 Factorial Randomized Tria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 and B are facto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 Active A and placebo A are levels within factor A and high-dose B and low-dose B are levels within factor B. Low-dose B is taken as the control condition for factor 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 Active A plus high-dose B, active A plus low-dose B, placebo A plus high-dose B, and placebo A plus low-dose B are the treatment groups. In a “full” factorial trial all participants are eligible to be randomized between each of the 4 treatment groups; in a “partial” factorial trial, a subset of participants would only be randomized between high- and low-dose B and assigned to placebo A without randomization. In a “factorial” analysis, all participants allocated to intervention A (active A plus low-dose B and active A plus high-dose B) are compared against those not allocated to A (placebo A plus low-dose B and placebo A plus high-dose B), and similarly for the comparison for intervention B. In a “multiarm” analysis, each of the treatment groups are compared against control (eg, active A plus high-dose B, active A plus low-dose B, and placebo A plus high-dose B are all compared against placebo A plus low-dose B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TextBox 11"/>
          <p:cNvSpPr/>
          <p:nvPr/>
        </p:nvSpPr>
        <p:spPr>
          <a:xfrm>
            <a:off x="0" y="5305320"/>
            <a:ext cx="915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0" tIns="0" bIns="63360" anchor="t">
            <a:normAutofit fontScale="36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256000">
                <a:solidFill>
                  <a:srgbClr val="ffffff"/>
                </a:solidFill>
                <a:latin typeface="Arial"/>
              </a:rPr>
              <a:t>Table Title: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Straight Connector 5"/>
          <p:cNvSpPr/>
          <p:nvPr/>
        </p:nvSpPr>
        <p:spPr>
          <a:xfrm>
            <a:off x="0" y="666720"/>
            <a:ext cx="9144000" cy="0"/>
          </a:xfrm>
          <a:prstGeom prst="line">
            <a:avLst/>
          </a:prstGeom>
          <a:ln w="38160">
            <a:solidFill>
              <a:srgbClr val="99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5" name="Picture 18" descr=""/>
          <p:cNvPicPr/>
          <p:nvPr/>
        </p:nvPicPr>
        <p:blipFill>
          <a:blip r:embed="rId1"/>
          <a:stretch/>
        </p:blipFill>
        <p:spPr>
          <a:xfrm>
            <a:off x="254160" y="101520"/>
            <a:ext cx="2286000" cy="482760"/>
          </a:xfrm>
          <a:prstGeom prst="rect">
            <a:avLst/>
          </a:prstGeom>
          <a:ln w="0">
            <a:noFill/>
          </a:ln>
        </p:spPr>
      </p:pic>
      <p:pic>
        <p:nvPicPr>
          <p:cNvPr id="556" name="New picture" descr=""/>
          <p:cNvPicPr/>
          <p:nvPr/>
        </p:nvPicPr>
        <p:blipFill>
          <a:blip r:embed="rId2"/>
          <a:stretch/>
        </p:blipFill>
        <p:spPr>
          <a:xfrm>
            <a:off x="3048120" y="2057400"/>
            <a:ext cx="3035160" cy="308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Lindsay Jacobik</cp:lastModifiedBy>
  <dcterms:modified xsi:type="dcterms:W3CDTF">2025-01-08T09:43:15Z</dcterms:modified>
  <cp:revision>56</cp:revision>
  <dc:subject/>
  <dc:title>Slide 1</dc:title>
</cp:coreProperties>
</file>